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3A171E6-58BF-42F0-B8E9-87E9E28E29D9}" v="10" dt="2023-12-21T21:24:51.6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9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mindi Seneviratne" userId="dccaeb4cfbf7da8e" providerId="LiveId" clId="{C3A171E6-58BF-42F0-B8E9-87E9E28E29D9}"/>
    <pc:docChg chg="custSel modSld">
      <pc:chgData name="Chamindi Seneviratne" userId="dccaeb4cfbf7da8e" providerId="LiveId" clId="{C3A171E6-58BF-42F0-B8E9-87E9E28E29D9}" dt="2023-12-21T21:37:23.785" v="568" actId="20577"/>
      <pc:docMkLst>
        <pc:docMk/>
      </pc:docMkLst>
      <pc:sldChg chg="addSp modSp mod">
        <pc:chgData name="Chamindi Seneviratne" userId="dccaeb4cfbf7da8e" providerId="LiveId" clId="{C3A171E6-58BF-42F0-B8E9-87E9E28E29D9}" dt="2023-12-21T21:37:23.785" v="568" actId="20577"/>
        <pc:sldMkLst>
          <pc:docMk/>
          <pc:sldMk cId="577874787" sldId="257"/>
        </pc:sldMkLst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4" creationId="{437271B4-508A-1B25-2824-A8170B2F5AC1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5" creationId="{1CA8F8F4-2FA0-587E-68EA-AC8B8D120711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6" creationId="{B87E9780-3CAE-3AE5-C2E6-FD4C39E6469C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7" creationId="{4409ED4D-5C9D-7078-679D-AC97310F1AB9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8" creationId="{FF76774B-C820-3DE2-987E-6409CC51A75E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9" creationId="{6938A014-2E5F-5292-98D1-F794C29C8486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10" creationId="{6F2C1FD5-DD20-F6EC-B95B-E275E06FF4BF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11" creationId="{90200672-615C-7905-3989-9B76954F32EA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12" creationId="{15B97BAF-092F-B2EC-E5DF-33D7E8497E4C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13" creationId="{1F271ACC-40AD-5898-42ED-F0D3FA75BFBF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14" creationId="{C332CEA9-71DE-FD2C-1301-DACDE29C0FDF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15" creationId="{93B3D546-E422-2092-5238-D0CA77FF6862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16" creationId="{C613D2E0-5F4C-2B2E-834D-9C2101E28CB3}"/>
          </ac:spMkLst>
        </pc:spChg>
        <pc:spChg chg="mod">
          <ac:chgData name="Chamindi Seneviratne" userId="dccaeb4cfbf7da8e" providerId="LiveId" clId="{C3A171E6-58BF-42F0-B8E9-87E9E28E29D9}" dt="2023-12-21T21:24:51.687" v="100" actId="1076"/>
          <ac:spMkLst>
            <pc:docMk/>
            <pc:sldMk cId="577874787" sldId="257"/>
            <ac:spMk id="17" creationId="{682C4379-33E1-4B84-7953-EDD102E3056F}"/>
          </ac:spMkLst>
        </pc:spChg>
        <pc:spChg chg="add mod">
          <ac:chgData name="Chamindi Seneviratne" userId="dccaeb4cfbf7da8e" providerId="LiveId" clId="{C3A171E6-58BF-42F0-B8E9-87E9E28E29D9}" dt="2023-12-21T21:37:23.785" v="568" actId="20577"/>
          <ac:spMkLst>
            <pc:docMk/>
            <pc:sldMk cId="577874787" sldId="257"/>
            <ac:spMk id="20" creationId="{41D8D407-A6AA-9B21-1D80-EDF996A99AE9}"/>
          </ac:spMkLst>
        </pc:spChg>
        <pc:spChg chg="add mod">
          <ac:chgData name="Chamindi Seneviratne" userId="dccaeb4cfbf7da8e" providerId="LiveId" clId="{C3A171E6-58BF-42F0-B8E9-87E9E28E29D9}" dt="2023-12-21T21:34:12.246" v="567" actId="20577"/>
          <ac:spMkLst>
            <pc:docMk/>
            <pc:sldMk cId="577874787" sldId="257"/>
            <ac:spMk id="22" creationId="{DA24985F-A328-F745-A345-D3D7F6E507F2}"/>
          </ac:spMkLst>
        </pc:spChg>
        <pc:grpChg chg="mod">
          <ac:chgData name="Chamindi Seneviratne" userId="dccaeb4cfbf7da8e" providerId="LiveId" clId="{C3A171E6-58BF-42F0-B8E9-87E9E28E29D9}" dt="2023-12-21T21:24:51.687" v="100" actId="1076"/>
          <ac:grpSpMkLst>
            <pc:docMk/>
            <pc:sldMk cId="577874787" sldId="257"/>
            <ac:grpSpMk id="18" creationId="{F1BB2403-2B83-5D50-B9D4-1B2D8DB2F6CB}"/>
          </ac:grpSpMkLst>
        </pc:grpChg>
        <pc:picChg chg="mod">
          <ac:chgData name="Chamindi Seneviratne" userId="dccaeb4cfbf7da8e" providerId="LiveId" clId="{C3A171E6-58BF-42F0-B8E9-87E9E28E29D9}" dt="2023-12-21T21:24:51.687" v="100" actId="1076"/>
          <ac:picMkLst>
            <pc:docMk/>
            <pc:sldMk cId="577874787" sldId="257"/>
            <ac:picMk id="2049" creationId="{ED061616-0F9C-D0CD-4CA9-E429A4B1ED8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7DD0A-43E2-3CD1-960E-A8E6060D00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BD8917-3A2B-951A-912A-0A7C4BCD56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2F790-61E3-91A9-8140-6618B4554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066446-FD21-B163-684A-0626B239F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4823FA-8D34-18E8-3F34-AC6D4F08F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089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0B4E3-688C-20DA-6DCC-656F9D07A7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C96FC0-2116-3141-7A21-022F37B5B2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B8F417-F9B6-0167-33A3-E8D95DB79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201C84-693B-F671-ECD4-88E1E2E4A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469F56-0530-3188-849F-24B46B14A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021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6C9D39-84D3-A5E0-DA7F-3CCEDF953A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85E588-7533-5A89-9DCF-FCDD8A772A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54361C-5CF2-2410-A424-F2CCA54BF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519330-E987-4194-160B-EA7A9DDDE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35B3DF-1078-5336-66EC-2113C7ABE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068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C09B66-923A-CEA1-0367-0618A56092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677EA6-E211-4E4D-AC4A-4919653BCD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EC99C-2CBE-27D7-928F-CFCB448BB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6D1344-BB24-D7E9-7D9C-E9894784D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21A30-B8EE-9799-C0A5-46DFC50C4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858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19DD4B-F7AF-A5E6-6EB8-98D6E9D06D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265331-B91B-AC29-F527-80701CB101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3531E4-DB28-0B95-DF82-E8661AB60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D4932B-BF35-5C9E-7410-25E51CB83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9A7DFB-B4B8-9205-0FD2-688F737A7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111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2E1F9-C38D-BE3D-90B0-27DAC0BC1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870A9A-A583-B1AA-4E79-10CF850E90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B88520-6168-908A-0914-FF6FA4EDC9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5D5B36-917E-48FE-0326-60F4E36D1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0EFC63-CF9D-5289-C2A4-F312D2DEC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161703-3677-8F9A-1496-84EF0DBAA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224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DE1D24-CD59-1B6B-C67B-169B655A3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E3DE13-BBB9-CB05-2E4D-C2070B1CDD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F2ADAF-2915-36BF-EA62-DD79A3295D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54AF642-5512-87F6-FAF7-247B63F2C7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2472F5-7EEE-88F1-6AB5-385A1B73C0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93ABA1-8829-5C46-1E1C-B973C9EF3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A32A68-5C47-FDCF-BD86-77EFA5138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A3E8A1A-B257-CC62-3274-4EA403130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33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B0C48D-8569-430B-2BD5-E0B806E3CE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338526-7169-34B1-DFC4-4E7DE7E1EE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68D8C8-2CA7-57D9-BB03-206605602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03B145-EA81-DFAE-608C-1C0659D26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729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CDAB65-90E2-7F93-1AC8-7374502A0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72CB5C-4CD8-6046-D1B0-7D44FC203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2C6C771-9E9B-8213-7255-2B6F82E859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0F8529-CA29-A7E3-C6A1-FC8A8D97E5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A37B87-F52F-7E54-393D-A0A9EA2B9B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38E349-F637-63D7-CDA9-32E1B79C97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76D028-67AA-A949-CF97-734A617BE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43FD1A-56AA-4A22-C923-A65973869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118B02-7134-012F-0934-9A9EEAE47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715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EDA76-555C-FA3E-902A-45F51AEFD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A377068-92E8-9B2C-62DD-21F7B2D4BF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D0E3BD-78DA-405B-3B4A-0253776CD2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EFC13C-83A3-E012-5F29-13D23AF7E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9B0D37-FCDD-B1A9-60AC-51F72564E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2B160E-7EBD-90DD-C2F3-545F4F411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274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8600CA-45D8-7542-E45E-EBE040229D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D56E2D-B06E-EC5A-8191-F9041D3370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A2FF65-D43D-9B87-7C76-5F413FDAB3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778591-B3FF-4C3B-96B2-CFAE5A79AE51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88ABD-A7B9-4460-39F8-DBD5FFAD29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C4CBF-9DD9-35E0-1A68-5723D97708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0A801D-3EBF-4E1B-8944-24011EF214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244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F1BB2403-2B83-5D50-B9D4-1B2D8DB2F6CB}"/>
              </a:ext>
            </a:extLst>
          </p:cNvPr>
          <p:cNvGrpSpPr/>
          <p:nvPr/>
        </p:nvGrpSpPr>
        <p:grpSpPr>
          <a:xfrm rot="16200000">
            <a:off x="2674756" y="-1149953"/>
            <a:ext cx="4835060" cy="8451774"/>
            <a:chOff x="-58944" y="-514222"/>
            <a:chExt cx="9201530" cy="13120560"/>
          </a:xfrm>
        </p:grpSpPr>
        <p:pic>
          <p:nvPicPr>
            <p:cNvPr id="2049" name="Image 12">
              <a:extLst>
                <a:ext uri="{FF2B5EF4-FFF2-40B4-BE49-F238E27FC236}">
                  <a16:creationId xmlns:a16="http://schemas.microsoft.com/office/drawing/2014/main" id="{ED061616-0F9C-D0CD-4CA9-E429A4B1ED86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0401" y="565150"/>
              <a:ext cx="8254999" cy="1204118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1">
              <a:extLst>
                <a:ext uri="{FF2B5EF4-FFF2-40B4-BE49-F238E27FC236}">
                  <a16:creationId xmlns:a16="http://schemas.microsoft.com/office/drawing/2014/main" id="{437271B4-508A-1B25-2824-A8170B2F5A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400000">
              <a:off x="-325015" y="1679164"/>
              <a:ext cx="1322916" cy="374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Individual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2">
              <a:extLst>
                <a:ext uri="{FF2B5EF4-FFF2-40B4-BE49-F238E27FC236}">
                  <a16:creationId xmlns:a16="http://schemas.microsoft.com/office/drawing/2014/main" id="{1CA8F8F4-2FA0-587E-68EA-AC8B8D12071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400000">
              <a:off x="-94308" y="3476337"/>
              <a:ext cx="888490" cy="401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Gender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3">
              <a:extLst>
                <a:ext uri="{FF2B5EF4-FFF2-40B4-BE49-F238E27FC236}">
                  <a16:creationId xmlns:a16="http://schemas.microsoft.com/office/drawing/2014/main" id="{B87E9780-3CAE-3AE5-C2E6-FD4C39E646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400000">
              <a:off x="-441771" y="5209297"/>
              <a:ext cx="1445665" cy="6800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Time Point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4">
              <a:extLst>
                <a:ext uri="{FF2B5EF4-FFF2-40B4-BE49-F238E27FC236}">
                  <a16:creationId xmlns:a16="http://schemas.microsoft.com/office/drawing/2014/main" id="{4409ED4D-5C9D-7078-679D-AC97310F1A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400000">
              <a:off x="-377473" y="7295625"/>
              <a:ext cx="1253980" cy="6169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Treatment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5">
              <a:extLst>
                <a:ext uri="{FF2B5EF4-FFF2-40B4-BE49-F238E27FC236}">
                  <a16:creationId xmlns:a16="http://schemas.microsoft.com/office/drawing/2014/main" id="{FF76774B-C820-3DE2-987E-6409CC51A7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400000">
              <a:off x="105044" y="9481749"/>
              <a:ext cx="599322" cy="374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Visit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6">
              <a:extLst>
                <a:ext uri="{FF2B5EF4-FFF2-40B4-BE49-F238E27FC236}">
                  <a16:creationId xmlns:a16="http://schemas.microsoft.com/office/drawing/2014/main" id="{6938A014-2E5F-5292-98D1-F794C29C84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400000">
              <a:off x="-396110" y="11282317"/>
              <a:ext cx="1253980" cy="5796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Residuals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7">
              <a:extLst>
                <a:ext uri="{FF2B5EF4-FFF2-40B4-BE49-F238E27FC236}">
                  <a16:creationId xmlns:a16="http://schemas.microsoft.com/office/drawing/2014/main" id="{6F2C1FD5-DD20-F6EC-B95B-E275E06FF4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406735" y="304867"/>
              <a:ext cx="735851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100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8">
              <a:extLst>
                <a:ext uri="{FF2B5EF4-FFF2-40B4-BE49-F238E27FC236}">
                  <a16:creationId xmlns:a16="http://schemas.microsoft.com/office/drawing/2014/main" id="{90200672-615C-7905-3989-9B76954F32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66067" y="293064"/>
              <a:ext cx="596148" cy="4234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75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9">
              <a:extLst>
                <a:ext uri="{FF2B5EF4-FFF2-40B4-BE49-F238E27FC236}">
                  <a16:creationId xmlns:a16="http://schemas.microsoft.com/office/drawing/2014/main" id="{15B97BAF-092F-B2EC-E5DF-33D7E8497E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56148" y="371447"/>
              <a:ext cx="769101" cy="266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50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0">
              <a:extLst>
                <a:ext uri="{FF2B5EF4-FFF2-40B4-BE49-F238E27FC236}">
                  <a16:creationId xmlns:a16="http://schemas.microsoft.com/office/drawing/2014/main" id="{1F271ACC-40AD-5898-42ED-F0D3FA75BF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88881" y="355011"/>
              <a:ext cx="419314" cy="1198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25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1">
              <a:extLst>
                <a:ext uri="{FF2B5EF4-FFF2-40B4-BE49-F238E27FC236}">
                  <a16:creationId xmlns:a16="http://schemas.microsoft.com/office/drawing/2014/main" id="{C332CEA9-71DE-FD2C-1301-DACDE29C0F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33353" y="266757"/>
              <a:ext cx="784498" cy="3246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0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3">
              <a:extLst>
                <a:ext uri="{FF2B5EF4-FFF2-40B4-BE49-F238E27FC236}">
                  <a16:creationId xmlns:a16="http://schemas.microsoft.com/office/drawing/2014/main" id="{93B3D546-E422-2092-5238-D0CA77FF68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3621" y="48707"/>
              <a:ext cx="304756" cy="3597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25">
              <a:extLst>
                <a:ext uri="{FF2B5EF4-FFF2-40B4-BE49-F238E27FC236}">
                  <a16:creationId xmlns:a16="http://schemas.microsoft.com/office/drawing/2014/main" id="{C613D2E0-5F4C-2B2E-834D-9C2101E28C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0289" y="-514222"/>
              <a:ext cx="3490765" cy="9714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Variance explained (%)</a:t>
              </a:r>
              <a:endPara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26">
              <a:extLst>
                <a:ext uri="{FF2B5EF4-FFF2-40B4-BE49-F238E27FC236}">
                  <a16:creationId xmlns:a16="http://schemas.microsoft.com/office/drawing/2014/main" id="{682C4379-33E1-4B84-7953-EDD102E305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3620" y="156148"/>
              <a:ext cx="304756" cy="6116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br>
                <a: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</a:br>
              <a:endParaRPr kumimoji="0" lang="en-US" altLang="en-US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41D8D407-A6AA-9B21-1D80-EDF996A99AE9}"/>
              </a:ext>
            </a:extLst>
          </p:cNvPr>
          <p:cNvSpPr txBox="1"/>
          <p:nvPr/>
        </p:nvSpPr>
        <p:spPr>
          <a:xfrm>
            <a:off x="685620" y="258294"/>
            <a:ext cx="1038428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i="0" dirty="0">
                <a:solidFill>
                  <a:srgbClr val="24242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: </a:t>
            </a:r>
            <a:r>
              <a:rPr lang="en-US" sz="2000" b="0" i="0" dirty="0">
                <a:solidFill>
                  <a:srgbClr val="24242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jor drivers of variance in the cohort sequenced using </a:t>
            </a:r>
            <a:r>
              <a:rPr lang="en-US" sz="2000" b="0" i="0" dirty="0" err="1">
                <a:solidFill>
                  <a:srgbClr val="24242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US" sz="2000" b="0" i="0" dirty="0">
                <a:solidFill>
                  <a:srgbClr val="24242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24985F-A328-F745-A345-D3D7F6E507F2}"/>
              </a:ext>
            </a:extLst>
          </p:cNvPr>
          <p:cNvSpPr txBox="1"/>
          <p:nvPr/>
        </p:nvSpPr>
        <p:spPr>
          <a:xfrm>
            <a:off x="588003" y="5815964"/>
            <a:ext cx="101786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violin plots demonstrate the variance in gene expression attributed to the factors shown on the x-axis, as identified by variance partition analysis. The horizontal lines within the violin plots indicate the population median for data distribu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7874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</TotalTime>
  <Words>71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mindi Seneviratne</dc:creator>
  <cp:lastModifiedBy>Chamindi Seneviratne</cp:lastModifiedBy>
  <cp:revision>1</cp:revision>
  <dcterms:created xsi:type="dcterms:W3CDTF">2023-12-21T15:36:12Z</dcterms:created>
  <dcterms:modified xsi:type="dcterms:W3CDTF">2023-12-21T21:37:29Z</dcterms:modified>
</cp:coreProperties>
</file>